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Default Extension="tif" ContentType="image/tiff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39" userDrawn="1">
          <p15:clr>
            <a:srgbClr val="A4A3A4"/>
          </p15:clr>
        </p15:guide>
        <p15:guide id="2" pos="3262" userDrawn="1">
          <p15:clr>
            <a:srgbClr val="A4A3A4"/>
          </p15:clr>
        </p15:guide>
        <p15:guide id="3" pos="4041" userDrawn="1">
          <p15:clr>
            <a:srgbClr val="A4A3A4"/>
          </p15:clr>
        </p15:guide>
        <p15:guide id="4" pos="3633" userDrawn="1">
          <p15:clr>
            <a:srgbClr val="A4A3A4"/>
          </p15:clr>
        </p15:guide>
        <p15:guide id="5" pos="4248" userDrawn="1">
          <p15:clr>
            <a:srgbClr val="A4A3A4"/>
          </p15:clr>
        </p15:guide>
        <p15:guide id="6" orient="horz" pos="1058" userDrawn="1">
          <p15:clr>
            <a:srgbClr val="A4A3A4"/>
          </p15:clr>
        </p15:guide>
        <p15:guide id="7" orient="horz" pos="1500" userDrawn="1">
          <p15:clr>
            <a:srgbClr val="A4A3A4"/>
          </p15:clr>
        </p15:guide>
        <p15:guide id="8" orient="horz" pos="9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564" y="96"/>
      </p:cViewPr>
      <p:guideLst>
        <p:guide orient="horz" pos="2339"/>
        <p:guide pos="3262"/>
        <p:guide pos="4041"/>
        <p:guide pos="3633"/>
        <p:guide pos="4248"/>
        <p:guide orient="horz" pos="1058"/>
        <p:guide orient="horz" pos="1500"/>
        <p:guide orient="horz" pos="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083722222222222"/>
          <c:y val="6.52787037037037E-2"/>
          <c:w val="0.72682944444444442"/>
          <c:h val="0.594442129629629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upple Fig 1'!$AG$4:$AG$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4328862621609639</c:v>
                  </c:pt>
                  <c:pt idx="2">
                    <c:v>0.76494981174619392</c:v>
                  </c:pt>
                  <c:pt idx="3">
                    <c:v>2.02203855918960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upple Fig 1'!$AE$4:$AE$7</c:f>
              <c:strCache>
                <c:ptCount val="4"/>
                <c:pt idx="0">
                  <c:v>+bFGF / Vec</c:v>
                </c:pt>
                <c:pt idx="1">
                  <c:v>+bFGF / Hpca</c:v>
                </c:pt>
                <c:pt idx="2">
                  <c:v>-bFGF / Vec</c:v>
                </c:pt>
                <c:pt idx="3">
                  <c:v>-bFGF / Hpca</c:v>
                </c:pt>
              </c:strCache>
            </c:strRef>
          </c:cat>
          <c:val>
            <c:numRef>
              <c:f>'Supple Fig 1'!$AF$4:$AF$7</c:f>
              <c:numCache>
                <c:formatCode>0.00</c:formatCode>
                <c:ptCount val="4"/>
                <c:pt idx="0" formatCode="0.00_ ">
                  <c:v>1</c:v>
                </c:pt>
                <c:pt idx="1">
                  <c:v>4.6635145746959568</c:v>
                </c:pt>
                <c:pt idx="2" formatCode="0.00_ ">
                  <c:v>3.3270753284771311</c:v>
                </c:pt>
                <c:pt idx="3">
                  <c:v>7.5265588854080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E5-455D-BEE7-2594434B4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39307904"/>
        <c:axId val="339302656"/>
      </c:barChart>
      <c:catAx>
        <c:axId val="339307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9302656"/>
        <c:crosses val="autoZero"/>
        <c:auto val="1"/>
        <c:lblAlgn val="ctr"/>
        <c:lblOffset val="100"/>
        <c:noMultiLvlLbl val="0"/>
      </c:catAx>
      <c:valAx>
        <c:axId val="339302656"/>
        <c:scaling>
          <c:orientation val="minMax"/>
          <c:max val="10"/>
        </c:scaling>
        <c:delete val="0"/>
        <c:axPos val="l"/>
        <c:numFmt formatCode="0_ 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930790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5934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0474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6132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94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1427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4683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2546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653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29927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0980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5432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B7449-9A09-4EA5-B912-EFDCAC7346DB}" type="datetimeFigureOut">
              <a:rPr lang="ko-KR" altLang="en-US" smtClean="0"/>
              <a:t>2016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35906-CE0B-4D82-9C24-F2A47DECAC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1909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차트 4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6125732"/>
              </p:ext>
            </p:extLst>
          </p:nvPr>
        </p:nvGraphicFramePr>
        <p:xfrm>
          <a:off x="5184477" y="1553163"/>
          <a:ext cx="180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8" name="그림 27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0308" y="2897150"/>
            <a:ext cx="1260000" cy="4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그림 28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0308" y="2387399"/>
            <a:ext cx="1260000" cy="4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2727254" y="2472594"/>
            <a:ext cx="72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GFAP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27254" y="2981629"/>
            <a:ext cx="720000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722371" y="1882662"/>
            <a:ext cx="720000" cy="43088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 (HPCA)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4487833" y="2160492"/>
            <a:ext cx="1261378" cy="4001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ko-KR"/>
            </a:defPPr>
            <a:lvl1pPr>
              <a:defRPr sz="1200"/>
            </a:lvl1pPr>
          </a:lstStyle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GFAP/GAPDH</a:t>
            </a:r>
          </a:p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(Fold increases)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 flipV="1">
            <a:off x="5762097" y="2007266"/>
            <a:ext cx="0" cy="7704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6" name="직선 연결선 35"/>
          <p:cNvCxnSpPr/>
          <p:nvPr/>
        </p:nvCxnSpPr>
        <p:spPr>
          <a:xfrm>
            <a:off x="5759716" y="2012130"/>
            <a:ext cx="3240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7" name="직선 연결선 36"/>
          <p:cNvCxnSpPr/>
          <p:nvPr/>
        </p:nvCxnSpPr>
        <p:spPr>
          <a:xfrm flipH="1">
            <a:off x="6090339" y="2005842"/>
            <a:ext cx="1" cy="108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8" name="직선 연결선 37"/>
          <p:cNvCxnSpPr/>
          <p:nvPr/>
        </p:nvCxnSpPr>
        <p:spPr>
          <a:xfrm>
            <a:off x="6742582" y="1573171"/>
            <a:ext cx="0" cy="108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39" name="직선 연결선 38"/>
          <p:cNvCxnSpPr/>
          <p:nvPr/>
        </p:nvCxnSpPr>
        <p:spPr>
          <a:xfrm flipV="1">
            <a:off x="6414762" y="1571047"/>
            <a:ext cx="0" cy="72000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cxnSp>
        <p:nvCxnSpPr>
          <p:cNvPr id="40" name="직선 연결선 39"/>
          <p:cNvCxnSpPr/>
          <p:nvPr/>
        </p:nvCxnSpPr>
        <p:spPr>
          <a:xfrm>
            <a:off x="6415006" y="1575906"/>
            <a:ext cx="334800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1" name="TextBox 40"/>
          <p:cNvSpPr txBox="1"/>
          <p:nvPr/>
        </p:nvSpPr>
        <p:spPr>
          <a:xfrm>
            <a:off x="5832141" y="1797258"/>
            <a:ext cx="179999" cy="307777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sz="14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</a:t>
            </a:r>
          </a:p>
        </p:txBody>
      </p:sp>
      <p:pic>
        <p:nvPicPr>
          <p:cNvPr id="42" name="그림 41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0308" y="1882105"/>
            <a:ext cx="1260000" cy="43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/>
          <p:cNvSpPr txBox="1"/>
          <p:nvPr/>
        </p:nvSpPr>
        <p:spPr>
          <a:xfrm>
            <a:off x="6402406" y="1354004"/>
            <a:ext cx="360000" cy="307777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ko-KR" altLang="en-US" sz="1400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**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449235" y="1617300"/>
            <a:ext cx="1261073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defTabSz="457200" latinLnBrk="0"/>
            <a:r>
              <a:rPr lang="en-US" altLang="ko-K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     -     +     -     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884097" y="1598836"/>
            <a:ext cx="612349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 defTabSz="457200" latinLnBrk="0"/>
            <a:r>
              <a:rPr lang="en-US" altLang="ko-KR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FGF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>
          <a:xfrm>
            <a:off x="3478766" y="1593682"/>
            <a:ext cx="540000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7" name="TextBox 46"/>
          <p:cNvSpPr txBox="1"/>
          <p:nvPr/>
        </p:nvSpPr>
        <p:spPr>
          <a:xfrm>
            <a:off x="3427663" y="1281492"/>
            <a:ext cx="648000" cy="32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 defTabSz="457200" latinLnBrk="0"/>
            <a:r>
              <a:rPr lang="en-US" altLang="ko-KR" sz="11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ctor 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연결선 47"/>
          <p:cNvCxnSpPr/>
          <p:nvPr/>
        </p:nvCxnSpPr>
        <p:spPr>
          <a:xfrm>
            <a:off x="4104933" y="1590265"/>
            <a:ext cx="540000" cy="7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</a:ln>
          <a:effectLst/>
        </p:spPr>
      </p:cxnSp>
      <p:sp>
        <p:nvSpPr>
          <p:cNvPr id="49" name="TextBox 48"/>
          <p:cNvSpPr txBox="1"/>
          <p:nvPr/>
        </p:nvSpPr>
        <p:spPr>
          <a:xfrm>
            <a:off x="4126766" y="1274541"/>
            <a:ext cx="540000" cy="32400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 defTabSz="457200" latinLnBrk="0"/>
            <a:r>
              <a:rPr lang="en-US" altLang="ko-KR" sz="11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pca</a:t>
            </a:r>
            <a:endParaRPr lang="ko-KR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62"/>
          <p:cNvSpPr txBox="1">
            <a:spLocks noChangeArrowheads="1"/>
          </p:cNvSpPr>
          <p:nvPr/>
        </p:nvSpPr>
        <p:spPr bwMode="auto">
          <a:xfrm>
            <a:off x="171052" y="116632"/>
            <a:ext cx="792934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Supplemental Fig 1. 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1043796" y="4365104"/>
            <a:ext cx="1009290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0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Effect of 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pca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 on GFAP expression during differentiation of HNPCs.</a:t>
            </a:r>
          </a:p>
          <a:p>
            <a:pPr latinLnBrk="0"/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HNPCs were transiently transfected with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pMSCV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-IRES-EGFP or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pMSCV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-IRES-EGFP-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Hpca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for 48 h and allowed to differentiate for 24 h. Cell lysates were analyzed by western blotting with anti-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, anti-GFAP, and anti-β-actin. The intensity of bands was quantified using Quantity Ones® software (Bio-Rad). Graph shows mean densities as fold increases in three independent experiments (mean ± SD). *p&lt;0.05 compared with the +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bFGF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/vector control. **p&lt;0.05 compared with -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bFGF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/vector control.</a:t>
            </a:r>
            <a:endParaRPr lang="ko-KR" altLang="ko-K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1581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96B19D74A42C41A7919B8D7F958A8A" ma:contentTypeVersion="7" ma:contentTypeDescription="Create a new document." ma:contentTypeScope="" ma:versionID="1ec2d394f5915bd9604923642f828c53">
  <xsd:schema xmlns:xsd="http://www.w3.org/2001/XMLSchema" xmlns:p="http://schemas.microsoft.com/office/2006/metadata/properties" xmlns:ns2="b99bd956-035a-4b72-81f6-d7d59a5e1a83" targetNamespace="http://schemas.microsoft.com/office/2006/metadata/properties" ma:root="true" ma:fieldsID="6c8638eb55814138a1acaad38b4528c9" ns2:_="">
    <xsd:import namespace="b99bd956-035a-4b72-81f6-d7d59a5e1a8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99bd956-035a-4b72-81f6-d7d59a5e1a8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99bd956-035a-4b72-81f6-d7d59a5e1a83">
      <UserInfo>
        <DisplayName/>
        <AccountId xsi:nil="true"/>
        <AccountType/>
      </UserInfo>
    </Checked_x0020_Out_x0020_To>
    <DocumentType xmlns="b99bd956-035a-4b72-81f6-d7d59a5e1a83">Presentation</DocumentType>
    <DocumentId xmlns="b99bd956-035a-4b72-81f6-d7d59a5e1a83">Presentation 1.PPTX</DocumentId>
    <IsDeleted xmlns="b99bd956-035a-4b72-81f6-d7d59a5e1a83">false</IsDeleted>
    <FileFormat xmlns="b99bd956-035a-4b72-81f6-d7d59a5e1a83">PPTX</FileFormat>
    <StageName xmlns="b99bd956-035a-4b72-81f6-d7d59a5e1a83" xsi:nil="true"/>
    <TitleName xmlns="b99bd956-035a-4b72-81f6-d7d59a5e1a83">Presentation 1.PPTX</TitleName>
  </documentManagement>
</p:properties>
</file>

<file path=customXml/itemProps1.xml><?xml version="1.0" encoding="utf-8"?>
<ds:datastoreItem xmlns:ds="http://schemas.openxmlformats.org/officeDocument/2006/customXml" ds:itemID="{CF64A142-D294-42E9-91A3-98953295A702}"/>
</file>

<file path=customXml/itemProps2.xml><?xml version="1.0" encoding="utf-8"?>
<ds:datastoreItem xmlns:ds="http://schemas.openxmlformats.org/officeDocument/2006/customXml" ds:itemID="{D7F3AC66-742D-49DF-9616-015F869BCE4F}"/>
</file>

<file path=customXml/itemProps3.xml><?xml version="1.0" encoding="utf-8"?>
<ds:datastoreItem xmlns:ds="http://schemas.openxmlformats.org/officeDocument/2006/customXml" ds:itemID="{9A8B0E9F-5DE3-4281-A93E-F85295DE3415}"/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121</Words>
  <Application>Microsoft Office PowerPoint</Application>
  <PresentationFormat>와이드스크린</PresentationFormat>
  <Paragraphs>1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 Unicode MS</vt:lpstr>
      <vt:lpstr>等线</vt:lpstr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ngMin-Jeong</dc:creator>
  <cp:lastModifiedBy>KangMin-Jeong</cp:lastModifiedBy>
  <cp:revision>7</cp:revision>
  <dcterms:created xsi:type="dcterms:W3CDTF">2016-09-28T15:30:46Z</dcterms:created>
  <dcterms:modified xsi:type="dcterms:W3CDTF">2016-10-10T00:57:10Z</dcterms:modified>
</cp:coreProperties>
</file>